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5544800" cy="10058400"/>
  <p:notesSz cx="6858000" cy="9144000"/>
  <p:defaultTextStyle>
    <a:defPPr>
      <a:defRPr lang="en-US"/>
    </a:defPPr>
    <a:lvl1pPr marL="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1pPr>
    <a:lvl2pPr marL="7315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2pPr>
    <a:lvl3pPr marL="14630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3pPr>
    <a:lvl4pPr marL="21945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4pPr>
    <a:lvl5pPr marL="292608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5pPr>
    <a:lvl6pPr marL="365760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6pPr>
    <a:lvl7pPr marL="438912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7pPr>
    <a:lvl8pPr marL="512064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8pPr>
    <a:lvl9pPr marL="5852160" algn="l" defTabSz="1463040" rtl="0" eaLnBrk="1" latinLnBrk="0" hangingPunct="1">
      <a:defRPr sz="2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48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122" y="96"/>
      </p:cViewPr>
      <p:guideLst>
        <p:guide orient="horz" pos="3168"/>
        <p:guide pos="48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bolJ\AppData\Local\Microsoft\Windows\Temporary%20Internet%20Files\Content.Outlook\O6EKH6C1\Figuresrev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4035378328641548E-2"/>
          <c:y val="3.1238910130999935E-2"/>
          <c:w val="0.91854577982110097"/>
          <c:h val="0.639744480473668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5 16 PY '!$D$1</c:f>
              <c:strCache>
                <c:ptCount val="1"/>
                <c:pt idx="0">
                  <c:v>WHO tube test</c:v>
                </c:pt>
              </c:strCache>
            </c:strRef>
          </c:tx>
          <c:invertIfNegative val="0"/>
          <c:cat>
            <c:multiLvlStrRef>
              <c:f>'2015 16 PY '!$A$2:$C$45</c:f>
              <c:multiLvlStrCache>
                <c:ptCount val="44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 a-cypermethrin</c:v>
                  </c:pt>
                  <c:pt idx="21">
                    <c:v>deltamethrin</c:v>
                  </c:pt>
                  <c:pt idx="22">
                    <c:v>l-cyhalothrin</c:v>
                  </c:pt>
                  <c:pt idx="23">
                    <c:v>permethrin</c:v>
                  </c:pt>
                  <c:pt idx="24">
                    <c:v> a-cypermethrin</c:v>
                  </c:pt>
                  <c:pt idx="25">
                    <c:v>deltamethrin</c:v>
                  </c:pt>
                  <c:pt idx="26">
                    <c:v>l-cyhalothrin</c:v>
                  </c:pt>
                  <c:pt idx="27">
                    <c:v>permethrin</c:v>
                  </c:pt>
                  <c:pt idx="28">
                    <c:v> a-cypermethrin</c:v>
                  </c:pt>
                  <c:pt idx="29">
                    <c:v>deltamethrin</c:v>
                  </c:pt>
                  <c:pt idx="30">
                    <c:v>l-cyhalothrin</c:v>
                  </c:pt>
                  <c:pt idx="31">
                    <c:v>permethrin</c:v>
                  </c:pt>
                  <c:pt idx="32">
                    <c:v> a-cypermethrin</c:v>
                  </c:pt>
                  <c:pt idx="33">
                    <c:v>deltamethrin</c:v>
                  </c:pt>
                  <c:pt idx="34">
                    <c:v>l-cyhalothrin</c:v>
                  </c:pt>
                  <c:pt idx="35">
                    <c:v>permethrin</c:v>
                  </c:pt>
                  <c:pt idx="36">
                    <c:v> a-cypermethrin</c:v>
                  </c:pt>
                  <c:pt idx="37">
                    <c:v>deltamethrin</c:v>
                  </c:pt>
                  <c:pt idx="38">
                    <c:v>l-cyhalothrin</c:v>
                  </c:pt>
                  <c:pt idx="39">
                    <c:v>permethrin</c:v>
                  </c:pt>
                  <c:pt idx="40">
                    <c:v> a-cypermethrin</c:v>
                  </c:pt>
                  <c:pt idx="41">
                    <c:v>deltamethrin</c:v>
                  </c:pt>
                  <c:pt idx="42">
                    <c:v>l-cyhalothrin</c:v>
                  </c:pt>
                  <c:pt idx="43">
                    <c:v>permethrin</c:v>
                  </c:pt>
                </c:lvl>
                <c:lvl>
                  <c:pt idx="0">
                    <c:v>Milamaina</c:v>
                  </c:pt>
                  <c:pt idx="4">
                    <c:v> Imerina Imady </c:v>
                  </c:pt>
                  <c:pt idx="8">
                    <c:v>Ankafina Tsarafidy</c:v>
                  </c:pt>
                  <c:pt idx="12">
                    <c:v>Vohimarina</c:v>
                  </c:pt>
                  <c:pt idx="16">
                    <c:v>Bekily</c:v>
                  </c:pt>
                  <c:pt idx="20">
                    <c:v>Vohitrambato</c:v>
                  </c:pt>
                  <c:pt idx="24">
                    <c:v>Mahambo</c:v>
                  </c:pt>
                  <c:pt idx="28">
                    <c:v>Ambodifaho</c:v>
                  </c:pt>
                  <c:pt idx="32">
                    <c:v>Vavatenina</c:v>
                  </c:pt>
                  <c:pt idx="36">
                    <c:v>Manambotra Sud</c:v>
                  </c:pt>
                  <c:pt idx="40">
                    <c:v>Lopary</c:v>
                  </c:pt>
                </c:lvl>
                <c:lvl>
                  <c:pt idx="0">
                    <c:v>Fandriana</c:v>
                  </c:pt>
                  <c:pt idx="4">
                    <c:v> Ambositra </c:v>
                  </c:pt>
                  <c:pt idx="8">
                    <c:v>Ambohimahasoa</c:v>
                  </c:pt>
                  <c:pt idx="12">
                    <c:v>Fianarantsoa II</c:v>
                  </c:pt>
                  <c:pt idx="16">
                    <c:v>Bekily</c:v>
                  </c:pt>
                  <c:pt idx="20">
                    <c:v>Toamasina II</c:v>
                  </c:pt>
                  <c:pt idx="24">
                    <c:v>Fenerive East</c:v>
                  </c:pt>
                  <c:pt idx="28">
                    <c:v>Brickaville</c:v>
                  </c:pt>
                  <c:pt idx="32">
                    <c:v>Vavatenina</c:v>
                  </c:pt>
                  <c:pt idx="36">
                    <c:v>Farafangana</c:v>
                  </c:pt>
                  <c:pt idx="40">
                    <c:v>Vangaindrano</c:v>
                  </c:pt>
                </c:lvl>
              </c:multiLvlStrCache>
            </c:multiLvlStrRef>
          </c:cat>
          <c:val>
            <c:numRef>
              <c:f>'2015 16 PY '!$D$2:$D$45</c:f>
              <c:numCache>
                <c:formatCode>General</c:formatCode>
                <c:ptCount val="44"/>
                <c:pt idx="0">
                  <c:v>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5">
                  <c:v>100</c:v>
                </c:pt>
                <c:pt idx="6">
                  <c:v>96</c:v>
                </c:pt>
                <c:pt idx="7">
                  <c:v>99</c:v>
                </c:pt>
                <c:pt idx="9">
                  <c:v>100</c:v>
                </c:pt>
                <c:pt idx="10">
                  <c:v>99</c:v>
                </c:pt>
                <c:pt idx="11">
                  <c:v>97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7">
                  <c:v>100</c:v>
                </c:pt>
                <c:pt idx="18">
                  <c:v>85</c:v>
                </c:pt>
                <c:pt idx="19">
                  <c:v>80</c:v>
                </c:pt>
                <c:pt idx="20">
                  <c:v>0</c:v>
                </c:pt>
                <c:pt idx="21">
                  <c:v>92</c:v>
                </c:pt>
                <c:pt idx="22">
                  <c:v>99</c:v>
                </c:pt>
                <c:pt idx="23">
                  <c:v>100</c:v>
                </c:pt>
                <c:pt idx="24">
                  <c:v>0</c:v>
                </c:pt>
                <c:pt idx="25">
                  <c:v>99</c:v>
                </c:pt>
                <c:pt idx="26">
                  <c:v>99</c:v>
                </c:pt>
                <c:pt idx="27">
                  <c:v>99</c:v>
                </c:pt>
                <c:pt idx="29">
                  <c:v>100</c:v>
                </c:pt>
                <c:pt idx="30">
                  <c:v>99</c:v>
                </c:pt>
                <c:pt idx="31">
                  <c:v>100</c:v>
                </c:pt>
                <c:pt idx="33">
                  <c:v>98</c:v>
                </c:pt>
                <c:pt idx="34">
                  <c:v>100</c:v>
                </c:pt>
                <c:pt idx="35">
                  <c:v>82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2015 16 PY '!$E$1</c:f>
              <c:strCache>
                <c:ptCount val="1"/>
                <c:pt idx="0">
                  <c:v>CDC bottles assay</c:v>
                </c:pt>
              </c:strCache>
            </c:strRef>
          </c:tx>
          <c:invertIfNegative val="0"/>
          <c:cat>
            <c:multiLvlStrRef>
              <c:f>'2015 16 PY '!$A$2:$C$45</c:f>
              <c:multiLvlStrCache>
                <c:ptCount val="44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 a-cypermethrin</c:v>
                  </c:pt>
                  <c:pt idx="21">
                    <c:v>deltamethrin</c:v>
                  </c:pt>
                  <c:pt idx="22">
                    <c:v>l-cyhalothrin</c:v>
                  </c:pt>
                  <c:pt idx="23">
                    <c:v>permethrin</c:v>
                  </c:pt>
                  <c:pt idx="24">
                    <c:v> a-cypermethrin</c:v>
                  </c:pt>
                  <c:pt idx="25">
                    <c:v>deltamethrin</c:v>
                  </c:pt>
                  <c:pt idx="26">
                    <c:v>l-cyhalothrin</c:v>
                  </c:pt>
                  <c:pt idx="27">
                    <c:v>permethrin</c:v>
                  </c:pt>
                  <c:pt idx="28">
                    <c:v> a-cypermethrin</c:v>
                  </c:pt>
                  <c:pt idx="29">
                    <c:v>deltamethrin</c:v>
                  </c:pt>
                  <c:pt idx="30">
                    <c:v>l-cyhalothrin</c:v>
                  </c:pt>
                  <c:pt idx="31">
                    <c:v>permethrin</c:v>
                  </c:pt>
                  <c:pt idx="32">
                    <c:v> a-cypermethrin</c:v>
                  </c:pt>
                  <c:pt idx="33">
                    <c:v>deltamethrin</c:v>
                  </c:pt>
                  <c:pt idx="34">
                    <c:v>l-cyhalothrin</c:v>
                  </c:pt>
                  <c:pt idx="35">
                    <c:v>permethrin</c:v>
                  </c:pt>
                  <c:pt idx="36">
                    <c:v> a-cypermethrin</c:v>
                  </c:pt>
                  <c:pt idx="37">
                    <c:v>deltamethrin</c:v>
                  </c:pt>
                  <c:pt idx="38">
                    <c:v>l-cyhalothrin</c:v>
                  </c:pt>
                  <c:pt idx="39">
                    <c:v>permethrin</c:v>
                  </c:pt>
                  <c:pt idx="40">
                    <c:v> a-cypermethrin</c:v>
                  </c:pt>
                  <c:pt idx="41">
                    <c:v>deltamethrin</c:v>
                  </c:pt>
                  <c:pt idx="42">
                    <c:v>l-cyhalothrin</c:v>
                  </c:pt>
                  <c:pt idx="43">
                    <c:v>permethrin</c:v>
                  </c:pt>
                </c:lvl>
                <c:lvl>
                  <c:pt idx="0">
                    <c:v>Milamaina</c:v>
                  </c:pt>
                  <c:pt idx="4">
                    <c:v> Imerina Imady </c:v>
                  </c:pt>
                  <c:pt idx="8">
                    <c:v>Ankafina Tsarafidy</c:v>
                  </c:pt>
                  <c:pt idx="12">
                    <c:v>Vohimarina</c:v>
                  </c:pt>
                  <c:pt idx="16">
                    <c:v>Bekily</c:v>
                  </c:pt>
                  <c:pt idx="20">
                    <c:v>Vohitrambato</c:v>
                  </c:pt>
                  <c:pt idx="24">
                    <c:v>Mahambo</c:v>
                  </c:pt>
                  <c:pt idx="28">
                    <c:v>Ambodifaho</c:v>
                  </c:pt>
                  <c:pt idx="32">
                    <c:v>Vavatenina</c:v>
                  </c:pt>
                  <c:pt idx="36">
                    <c:v>Manambotra Sud</c:v>
                  </c:pt>
                  <c:pt idx="40">
                    <c:v>Lopary</c:v>
                  </c:pt>
                </c:lvl>
                <c:lvl>
                  <c:pt idx="0">
                    <c:v>Fandriana</c:v>
                  </c:pt>
                  <c:pt idx="4">
                    <c:v> Ambositra </c:v>
                  </c:pt>
                  <c:pt idx="8">
                    <c:v>Ambohimahasoa</c:v>
                  </c:pt>
                  <c:pt idx="12">
                    <c:v>Fianarantsoa II</c:v>
                  </c:pt>
                  <c:pt idx="16">
                    <c:v>Bekily</c:v>
                  </c:pt>
                  <c:pt idx="20">
                    <c:v>Toamasina II</c:v>
                  </c:pt>
                  <c:pt idx="24">
                    <c:v>Fenerive East</c:v>
                  </c:pt>
                  <c:pt idx="28">
                    <c:v>Brickaville</c:v>
                  </c:pt>
                  <c:pt idx="32">
                    <c:v>Vavatenina</c:v>
                  </c:pt>
                  <c:pt idx="36">
                    <c:v>Farafangana</c:v>
                  </c:pt>
                  <c:pt idx="40">
                    <c:v>Vangaindrano</c:v>
                  </c:pt>
                </c:lvl>
              </c:multiLvlStrCache>
            </c:multiLvlStrRef>
          </c:cat>
          <c:val>
            <c:numRef>
              <c:f>'2015 16 PY '!$E$2:$E$45</c:f>
              <c:numCache>
                <c:formatCode>General</c:formatCode>
                <c:ptCount val="44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5</c:v>
                </c:pt>
                <c:pt idx="5">
                  <c:v>99</c:v>
                </c:pt>
                <c:pt idx="6">
                  <c:v>97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68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98</c:v>
                </c:pt>
                <c:pt idx="18">
                  <c:v>80</c:v>
                </c:pt>
                <c:pt idx="19">
                  <c:v>75</c:v>
                </c:pt>
                <c:pt idx="20">
                  <c:v>97</c:v>
                </c:pt>
                <c:pt idx="21">
                  <c:v>91</c:v>
                </c:pt>
                <c:pt idx="22">
                  <c:v>99</c:v>
                </c:pt>
                <c:pt idx="23">
                  <c:v>95</c:v>
                </c:pt>
                <c:pt idx="24">
                  <c:v>91</c:v>
                </c:pt>
                <c:pt idx="25">
                  <c:v>100</c:v>
                </c:pt>
                <c:pt idx="26">
                  <c:v>100</c:v>
                </c:pt>
                <c:pt idx="27">
                  <c:v>100</c:v>
                </c:pt>
                <c:pt idx="28">
                  <c:v>100</c:v>
                </c:pt>
                <c:pt idx="29">
                  <c:v>100</c:v>
                </c:pt>
                <c:pt idx="30">
                  <c:v>100</c:v>
                </c:pt>
                <c:pt idx="31">
                  <c:v>95</c:v>
                </c:pt>
                <c:pt idx="32">
                  <c:v>99</c:v>
                </c:pt>
                <c:pt idx="33">
                  <c:v>96</c:v>
                </c:pt>
                <c:pt idx="34">
                  <c:v>99</c:v>
                </c:pt>
                <c:pt idx="35">
                  <c:v>89</c:v>
                </c:pt>
                <c:pt idx="36">
                  <c:v>10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6503784"/>
        <c:axId val="167026824"/>
      </c:barChart>
      <c:lineChart>
        <c:grouping val="standard"/>
        <c:varyColors val="0"/>
        <c:ser>
          <c:idx val="2"/>
          <c:order val="2"/>
          <c:tx>
            <c:strRef>
              <c:f>'2015 16 PY '!$F$1</c:f>
              <c:strCache>
                <c:ptCount val="1"/>
                <c:pt idx="0">
                  <c:v>SUS</c:v>
                </c:pt>
              </c:strCache>
            </c:strRef>
          </c:tx>
          <c:marker>
            <c:symbol val="none"/>
          </c:marker>
          <c:cat>
            <c:multiLvlStrRef>
              <c:f>'2015 16 PY '!$A$2:$C$45</c:f>
              <c:multiLvlStrCache>
                <c:ptCount val="44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 a-cypermethrin</c:v>
                  </c:pt>
                  <c:pt idx="21">
                    <c:v>deltamethrin</c:v>
                  </c:pt>
                  <c:pt idx="22">
                    <c:v>l-cyhalothrin</c:v>
                  </c:pt>
                  <c:pt idx="23">
                    <c:v>permethrin</c:v>
                  </c:pt>
                  <c:pt idx="24">
                    <c:v> a-cypermethrin</c:v>
                  </c:pt>
                  <c:pt idx="25">
                    <c:v>deltamethrin</c:v>
                  </c:pt>
                  <c:pt idx="26">
                    <c:v>l-cyhalothrin</c:v>
                  </c:pt>
                  <c:pt idx="27">
                    <c:v>permethrin</c:v>
                  </c:pt>
                  <c:pt idx="28">
                    <c:v> a-cypermethrin</c:v>
                  </c:pt>
                  <c:pt idx="29">
                    <c:v>deltamethrin</c:v>
                  </c:pt>
                  <c:pt idx="30">
                    <c:v>l-cyhalothrin</c:v>
                  </c:pt>
                  <c:pt idx="31">
                    <c:v>permethrin</c:v>
                  </c:pt>
                  <c:pt idx="32">
                    <c:v> a-cypermethrin</c:v>
                  </c:pt>
                  <c:pt idx="33">
                    <c:v>deltamethrin</c:v>
                  </c:pt>
                  <c:pt idx="34">
                    <c:v>l-cyhalothrin</c:v>
                  </c:pt>
                  <c:pt idx="35">
                    <c:v>permethrin</c:v>
                  </c:pt>
                  <c:pt idx="36">
                    <c:v> a-cypermethrin</c:v>
                  </c:pt>
                  <c:pt idx="37">
                    <c:v>deltamethrin</c:v>
                  </c:pt>
                  <c:pt idx="38">
                    <c:v>l-cyhalothrin</c:v>
                  </c:pt>
                  <c:pt idx="39">
                    <c:v>permethrin</c:v>
                  </c:pt>
                  <c:pt idx="40">
                    <c:v> a-cypermethrin</c:v>
                  </c:pt>
                  <c:pt idx="41">
                    <c:v>deltamethrin</c:v>
                  </c:pt>
                  <c:pt idx="42">
                    <c:v>l-cyhalothrin</c:v>
                  </c:pt>
                  <c:pt idx="43">
                    <c:v>permethrin</c:v>
                  </c:pt>
                </c:lvl>
                <c:lvl>
                  <c:pt idx="0">
                    <c:v>Milamaina</c:v>
                  </c:pt>
                  <c:pt idx="4">
                    <c:v> Imerina Imady </c:v>
                  </c:pt>
                  <c:pt idx="8">
                    <c:v>Ankafina Tsarafidy</c:v>
                  </c:pt>
                  <c:pt idx="12">
                    <c:v>Vohimarina</c:v>
                  </c:pt>
                  <c:pt idx="16">
                    <c:v>Bekily</c:v>
                  </c:pt>
                  <c:pt idx="20">
                    <c:v>Vohitrambato</c:v>
                  </c:pt>
                  <c:pt idx="24">
                    <c:v>Mahambo</c:v>
                  </c:pt>
                  <c:pt idx="28">
                    <c:v>Ambodifaho</c:v>
                  </c:pt>
                  <c:pt idx="32">
                    <c:v>Vavatenina</c:v>
                  </c:pt>
                  <c:pt idx="36">
                    <c:v>Manambotra Sud</c:v>
                  </c:pt>
                  <c:pt idx="40">
                    <c:v>Lopary</c:v>
                  </c:pt>
                </c:lvl>
                <c:lvl>
                  <c:pt idx="0">
                    <c:v>Fandriana</c:v>
                  </c:pt>
                  <c:pt idx="4">
                    <c:v> Ambositra </c:v>
                  </c:pt>
                  <c:pt idx="8">
                    <c:v>Ambohimahasoa</c:v>
                  </c:pt>
                  <c:pt idx="12">
                    <c:v>Fianarantsoa II</c:v>
                  </c:pt>
                  <c:pt idx="16">
                    <c:v>Bekily</c:v>
                  </c:pt>
                  <c:pt idx="20">
                    <c:v>Toamasina II</c:v>
                  </c:pt>
                  <c:pt idx="24">
                    <c:v>Fenerive East</c:v>
                  </c:pt>
                  <c:pt idx="28">
                    <c:v>Brickaville</c:v>
                  </c:pt>
                  <c:pt idx="32">
                    <c:v>Vavatenina</c:v>
                  </c:pt>
                  <c:pt idx="36">
                    <c:v>Farafangana</c:v>
                  </c:pt>
                  <c:pt idx="40">
                    <c:v>Vangaindrano</c:v>
                  </c:pt>
                </c:lvl>
              </c:multiLvlStrCache>
            </c:multiLvlStrRef>
          </c:cat>
          <c:val>
            <c:numRef>
              <c:f>'2015 16 PY '!$F$2:$F$45</c:f>
              <c:numCache>
                <c:formatCode>General</c:formatCode>
                <c:ptCount val="44"/>
                <c:pt idx="0">
                  <c:v>98</c:v>
                </c:pt>
                <c:pt idx="1">
                  <c:v>98</c:v>
                </c:pt>
                <c:pt idx="2">
                  <c:v>98</c:v>
                </c:pt>
                <c:pt idx="3">
                  <c:v>98</c:v>
                </c:pt>
                <c:pt idx="4">
                  <c:v>98</c:v>
                </c:pt>
                <c:pt idx="5">
                  <c:v>98</c:v>
                </c:pt>
                <c:pt idx="6">
                  <c:v>98</c:v>
                </c:pt>
                <c:pt idx="7">
                  <c:v>98</c:v>
                </c:pt>
                <c:pt idx="8">
                  <c:v>98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  <c:pt idx="20">
                  <c:v>98</c:v>
                </c:pt>
                <c:pt idx="21">
                  <c:v>98</c:v>
                </c:pt>
                <c:pt idx="22">
                  <c:v>98</c:v>
                </c:pt>
                <c:pt idx="23">
                  <c:v>98</c:v>
                </c:pt>
                <c:pt idx="24">
                  <c:v>98</c:v>
                </c:pt>
                <c:pt idx="25">
                  <c:v>98</c:v>
                </c:pt>
                <c:pt idx="26">
                  <c:v>98</c:v>
                </c:pt>
                <c:pt idx="27">
                  <c:v>98</c:v>
                </c:pt>
                <c:pt idx="28">
                  <c:v>98</c:v>
                </c:pt>
                <c:pt idx="29">
                  <c:v>98</c:v>
                </c:pt>
                <c:pt idx="30">
                  <c:v>98</c:v>
                </c:pt>
                <c:pt idx="31">
                  <c:v>98</c:v>
                </c:pt>
                <c:pt idx="32">
                  <c:v>98</c:v>
                </c:pt>
                <c:pt idx="33">
                  <c:v>98</c:v>
                </c:pt>
                <c:pt idx="34">
                  <c:v>98</c:v>
                </c:pt>
                <c:pt idx="35">
                  <c:v>98</c:v>
                </c:pt>
                <c:pt idx="36">
                  <c:v>98</c:v>
                </c:pt>
                <c:pt idx="37">
                  <c:v>98</c:v>
                </c:pt>
                <c:pt idx="38">
                  <c:v>98</c:v>
                </c:pt>
                <c:pt idx="39">
                  <c:v>98</c:v>
                </c:pt>
                <c:pt idx="40">
                  <c:v>98</c:v>
                </c:pt>
                <c:pt idx="41">
                  <c:v>98</c:v>
                </c:pt>
                <c:pt idx="42">
                  <c:v>98</c:v>
                </c:pt>
                <c:pt idx="43">
                  <c:v>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2015 16 PY '!$G$1</c:f>
              <c:strCache>
                <c:ptCount val="1"/>
                <c:pt idx="0">
                  <c:v>SR</c:v>
                </c:pt>
              </c:strCache>
            </c:strRef>
          </c:tx>
          <c:marker>
            <c:symbol val="none"/>
          </c:marker>
          <c:cat>
            <c:multiLvlStrRef>
              <c:f>'2015 16 PY '!$A$2:$C$45</c:f>
              <c:multiLvlStrCache>
                <c:ptCount val="44"/>
                <c:lvl>
                  <c:pt idx="0">
                    <c:v> a-cypermethrin</c:v>
                  </c:pt>
                  <c:pt idx="1">
                    <c:v>deltamethrin</c:v>
                  </c:pt>
                  <c:pt idx="2">
                    <c:v>l-cyhalothrin</c:v>
                  </c:pt>
                  <c:pt idx="3">
                    <c:v>permethrin</c:v>
                  </c:pt>
                  <c:pt idx="4">
                    <c:v> a-cypermethrin</c:v>
                  </c:pt>
                  <c:pt idx="5">
                    <c:v>deltamethrin</c:v>
                  </c:pt>
                  <c:pt idx="6">
                    <c:v>l-cyhalothrin</c:v>
                  </c:pt>
                  <c:pt idx="7">
                    <c:v>permethrin</c:v>
                  </c:pt>
                  <c:pt idx="8">
                    <c:v> a-cypermethrin</c:v>
                  </c:pt>
                  <c:pt idx="9">
                    <c:v>deltamethrin</c:v>
                  </c:pt>
                  <c:pt idx="10">
                    <c:v>l-cyhalothrin</c:v>
                  </c:pt>
                  <c:pt idx="11">
                    <c:v>permethrin</c:v>
                  </c:pt>
                  <c:pt idx="12">
                    <c:v> a-cypermethrin</c:v>
                  </c:pt>
                  <c:pt idx="13">
                    <c:v>deltamethrin</c:v>
                  </c:pt>
                  <c:pt idx="14">
                    <c:v>l-cyhalothrin</c:v>
                  </c:pt>
                  <c:pt idx="15">
                    <c:v>permethrin</c:v>
                  </c:pt>
                  <c:pt idx="16">
                    <c:v> a-cypermethrin</c:v>
                  </c:pt>
                  <c:pt idx="17">
                    <c:v>deltamethrin</c:v>
                  </c:pt>
                  <c:pt idx="18">
                    <c:v>l-cyhalothrin</c:v>
                  </c:pt>
                  <c:pt idx="19">
                    <c:v>permethrin</c:v>
                  </c:pt>
                  <c:pt idx="20">
                    <c:v> a-cypermethrin</c:v>
                  </c:pt>
                  <c:pt idx="21">
                    <c:v>deltamethrin</c:v>
                  </c:pt>
                  <c:pt idx="22">
                    <c:v>l-cyhalothrin</c:v>
                  </c:pt>
                  <c:pt idx="23">
                    <c:v>permethrin</c:v>
                  </c:pt>
                  <c:pt idx="24">
                    <c:v> a-cypermethrin</c:v>
                  </c:pt>
                  <c:pt idx="25">
                    <c:v>deltamethrin</c:v>
                  </c:pt>
                  <c:pt idx="26">
                    <c:v>l-cyhalothrin</c:v>
                  </c:pt>
                  <c:pt idx="27">
                    <c:v>permethrin</c:v>
                  </c:pt>
                  <c:pt idx="28">
                    <c:v> a-cypermethrin</c:v>
                  </c:pt>
                  <c:pt idx="29">
                    <c:v>deltamethrin</c:v>
                  </c:pt>
                  <c:pt idx="30">
                    <c:v>l-cyhalothrin</c:v>
                  </c:pt>
                  <c:pt idx="31">
                    <c:v>permethrin</c:v>
                  </c:pt>
                  <c:pt idx="32">
                    <c:v> a-cypermethrin</c:v>
                  </c:pt>
                  <c:pt idx="33">
                    <c:v>deltamethrin</c:v>
                  </c:pt>
                  <c:pt idx="34">
                    <c:v>l-cyhalothrin</c:v>
                  </c:pt>
                  <c:pt idx="35">
                    <c:v>permethrin</c:v>
                  </c:pt>
                  <c:pt idx="36">
                    <c:v> a-cypermethrin</c:v>
                  </c:pt>
                  <c:pt idx="37">
                    <c:v>deltamethrin</c:v>
                  </c:pt>
                  <c:pt idx="38">
                    <c:v>l-cyhalothrin</c:v>
                  </c:pt>
                  <c:pt idx="39">
                    <c:v>permethrin</c:v>
                  </c:pt>
                  <c:pt idx="40">
                    <c:v> a-cypermethrin</c:v>
                  </c:pt>
                  <c:pt idx="41">
                    <c:v>deltamethrin</c:v>
                  </c:pt>
                  <c:pt idx="42">
                    <c:v>l-cyhalothrin</c:v>
                  </c:pt>
                  <c:pt idx="43">
                    <c:v>permethrin</c:v>
                  </c:pt>
                </c:lvl>
                <c:lvl>
                  <c:pt idx="0">
                    <c:v>Milamaina</c:v>
                  </c:pt>
                  <c:pt idx="4">
                    <c:v> Imerina Imady </c:v>
                  </c:pt>
                  <c:pt idx="8">
                    <c:v>Ankafina Tsarafidy</c:v>
                  </c:pt>
                  <c:pt idx="12">
                    <c:v>Vohimarina</c:v>
                  </c:pt>
                  <c:pt idx="16">
                    <c:v>Bekily</c:v>
                  </c:pt>
                  <c:pt idx="20">
                    <c:v>Vohitrambato</c:v>
                  </c:pt>
                  <c:pt idx="24">
                    <c:v>Mahambo</c:v>
                  </c:pt>
                  <c:pt idx="28">
                    <c:v>Ambodifaho</c:v>
                  </c:pt>
                  <c:pt idx="32">
                    <c:v>Vavatenina</c:v>
                  </c:pt>
                  <c:pt idx="36">
                    <c:v>Manambotra Sud</c:v>
                  </c:pt>
                  <c:pt idx="40">
                    <c:v>Lopary</c:v>
                  </c:pt>
                </c:lvl>
                <c:lvl>
                  <c:pt idx="0">
                    <c:v>Fandriana</c:v>
                  </c:pt>
                  <c:pt idx="4">
                    <c:v> Ambositra </c:v>
                  </c:pt>
                  <c:pt idx="8">
                    <c:v>Ambohimahasoa</c:v>
                  </c:pt>
                  <c:pt idx="12">
                    <c:v>Fianarantsoa II</c:v>
                  </c:pt>
                  <c:pt idx="16">
                    <c:v>Bekily</c:v>
                  </c:pt>
                  <c:pt idx="20">
                    <c:v>Toamasina II</c:v>
                  </c:pt>
                  <c:pt idx="24">
                    <c:v>Fenerive East</c:v>
                  </c:pt>
                  <c:pt idx="28">
                    <c:v>Brickaville</c:v>
                  </c:pt>
                  <c:pt idx="32">
                    <c:v>Vavatenina</c:v>
                  </c:pt>
                  <c:pt idx="36">
                    <c:v>Farafangana</c:v>
                  </c:pt>
                  <c:pt idx="40">
                    <c:v>Vangaindrano</c:v>
                  </c:pt>
                </c:lvl>
              </c:multiLvlStrCache>
            </c:multiLvlStrRef>
          </c:cat>
          <c:val>
            <c:numRef>
              <c:f>'2015 16 PY '!$G$2:$G$45</c:f>
              <c:numCache>
                <c:formatCode>General</c:formatCode>
                <c:ptCount val="44"/>
                <c:pt idx="0">
                  <c:v>90</c:v>
                </c:pt>
                <c:pt idx="1">
                  <c:v>90</c:v>
                </c:pt>
                <c:pt idx="2">
                  <c:v>90</c:v>
                </c:pt>
                <c:pt idx="3">
                  <c:v>90</c:v>
                </c:pt>
                <c:pt idx="4">
                  <c:v>90</c:v>
                </c:pt>
                <c:pt idx="5">
                  <c:v>90</c:v>
                </c:pt>
                <c:pt idx="6">
                  <c:v>90</c:v>
                </c:pt>
                <c:pt idx="7">
                  <c:v>90</c:v>
                </c:pt>
                <c:pt idx="8">
                  <c:v>90</c:v>
                </c:pt>
                <c:pt idx="9">
                  <c:v>90</c:v>
                </c:pt>
                <c:pt idx="10">
                  <c:v>90</c:v>
                </c:pt>
                <c:pt idx="11">
                  <c:v>90</c:v>
                </c:pt>
                <c:pt idx="12">
                  <c:v>90</c:v>
                </c:pt>
                <c:pt idx="13">
                  <c:v>90</c:v>
                </c:pt>
                <c:pt idx="14">
                  <c:v>90</c:v>
                </c:pt>
                <c:pt idx="15">
                  <c:v>90</c:v>
                </c:pt>
                <c:pt idx="16">
                  <c:v>90</c:v>
                </c:pt>
                <c:pt idx="17">
                  <c:v>90</c:v>
                </c:pt>
                <c:pt idx="18">
                  <c:v>90</c:v>
                </c:pt>
                <c:pt idx="19">
                  <c:v>90</c:v>
                </c:pt>
                <c:pt idx="20">
                  <c:v>90</c:v>
                </c:pt>
                <c:pt idx="21">
                  <c:v>90</c:v>
                </c:pt>
                <c:pt idx="22">
                  <c:v>90</c:v>
                </c:pt>
                <c:pt idx="23">
                  <c:v>90</c:v>
                </c:pt>
                <c:pt idx="24">
                  <c:v>90</c:v>
                </c:pt>
                <c:pt idx="25">
                  <c:v>90</c:v>
                </c:pt>
                <c:pt idx="26">
                  <c:v>90</c:v>
                </c:pt>
                <c:pt idx="27">
                  <c:v>90</c:v>
                </c:pt>
                <c:pt idx="28">
                  <c:v>90</c:v>
                </c:pt>
                <c:pt idx="29">
                  <c:v>90</c:v>
                </c:pt>
                <c:pt idx="30">
                  <c:v>90</c:v>
                </c:pt>
                <c:pt idx="31">
                  <c:v>90</c:v>
                </c:pt>
                <c:pt idx="32">
                  <c:v>90</c:v>
                </c:pt>
                <c:pt idx="33">
                  <c:v>90</c:v>
                </c:pt>
                <c:pt idx="34">
                  <c:v>90</c:v>
                </c:pt>
                <c:pt idx="35">
                  <c:v>90</c:v>
                </c:pt>
                <c:pt idx="36">
                  <c:v>90</c:v>
                </c:pt>
                <c:pt idx="37">
                  <c:v>90</c:v>
                </c:pt>
                <c:pt idx="38">
                  <c:v>90</c:v>
                </c:pt>
                <c:pt idx="39">
                  <c:v>90</c:v>
                </c:pt>
                <c:pt idx="40">
                  <c:v>90</c:v>
                </c:pt>
                <c:pt idx="41">
                  <c:v>90</c:v>
                </c:pt>
                <c:pt idx="42">
                  <c:v>90</c:v>
                </c:pt>
                <c:pt idx="43">
                  <c:v>9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6503784"/>
        <c:axId val="167026824"/>
      </c:lineChart>
      <c:catAx>
        <c:axId val="166503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600" b="0" i="0" baseline="0"/>
            </a:pPr>
            <a:endParaRPr lang="en-US"/>
          </a:p>
        </c:txPr>
        <c:crossAx val="167026824"/>
        <c:crosses val="autoZero"/>
        <c:auto val="1"/>
        <c:lblAlgn val="ctr"/>
        <c:lblOffset val="100"/>
        <c:noMultiLvlLbl val="0"/>
      </c:catAx>
      <c:valAx>
        <c:axId val="167026824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 baseline="0"/>
            </a:pPr>
            <a:endParaRPr lang="en-US"/>
          </a:p>
        </c:txPr>
        <c:crossAx val="166503784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21147396693612047"/>
          <c:y val="0.94896876936359609"/>
          <c:w val="0.41037669211829203"/>
          <c:h val="4.2511527873403926E-2"/>
        </c:manualLayout>
      </c:layout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800" baseline="0">
          <a:latin typeface="Arial Narrow" panose="020B060602020203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099</cdr:x>
      <cdr:y>0.30192</cdr:y>
    </cdr:from>
    <cdr:to>
      <cdr:x>0.04068</cdr:x>
      <cdr:y>0.5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491215" y="3233263"/>
          <a:ext cx="1698985" cy="4117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1" dirty="0"/>
            <a:t>% Mortality 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3124624"/>
            <a:ext cx="1321308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31720" y="5699760"/>
            <a:ext cx="1088136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89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852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40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86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158427" y="591397"/>
            <a:ext cx="5945345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22387" y="591397"/>
            <a:ext cx="17576960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622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55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7932" y="6463454"/>
            <a:ext cx="13213080" cy="1997710"/>
          </a:xfrm>
        </p:spPr>
        <p:txBody>
          <a:bodyPr anchor="t"/>
          <a:lstStyle>
            <a:lvl1pPr algn="l">
              <a:defRPr sz="64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7932" y="4263180"/>
            <a:ext cx="13213080" cy="2200274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152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783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22388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42621" y="3441277"/>
            <a:ext cx="11761153" cy="9737090"/>
          </a:xfrm>
        </p:spPr>
        <p:txBody>
          <a:bodyPr/>
          <a:lstStyle>
            <a:lvl1pPr>
              <a:defRPr sz="4500"/>
            </a:lvl1pPr>
            <a:lvl2pPr>
              <a:defRPr sz="38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215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251499"/>
            <a:ext cx="6868320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77240" y="3189817"/>
            <a:ext cx="6868320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96543" y="2251499"/>
            <a:ext cx="6871018" cy="938318"/>
          </a:xfrm>
        </p:spPr>
        <p:txBody>
          <a:bodyPr anchor="b"/>
          <a:lstStyle>
            <a:lvl1pPr marL="0" indent="0">
              <a:buNone/>
              <a:defRPr sz="380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900" b="1"/>
            </a:lvl3pPr>
            <a:lvl4pPr marL="2194560" indent="0">
              <a:buNone/>
              <a:defRPr sz="2600" b="1"/>
            </a:lvl4pPr>
            <a:lvl5pPr marL="2926080" indent="0">
              <a:buNone/>
              <a:defRPr sz="2600" b="1"/>
            </a:lvl5pPr>
            <a:lvl6pPr marL="3657600" indent="0">
              <a:buNone/>
              <a:defRPr sz="2600" b="1"/>
            </a:lvl6pPr>
            <a:lvl7pPr marL="4389120" indent="0">
              <a:buNone/>
              <a:defRPr sz="2600" b="1"/>
            </a:lvl7pPr>
            <a:lvl8pPr marL="5120640" indent="0">
              <a:buNone/>
              <a:defRPr sz="2600" b="1"/>
            </a:lvl8pPr>
            <a:lvl9pPr marL="585216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96543" y="3189817"/>
            <a:ext cx="6871018" cy="5795222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41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10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414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7241" y="400473"/>
            <a:ext cx="5114132" cy="1704340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77585" y="400474"/>
            <a:ext cx="8689975" cy="8584566"/>
          </a:xfrm>
        </p:spPr>
        <p:txBody>
          <a:bodyPr/>
          <a:lstStyle>
            <a:lvl1pPr>
              <a:defRPr sz="5100"/>
            </a:lvl1pPr>
            <a:lvl2pPr>
              <a:defRPr sz="4500"/>
            </a:lvl2pPr>
            <a:lvl3pPr>
              <a:defRPr sz="38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77241" y="2104814"/>
            <a:ext cx="5114132" cy="6880226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814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6890" y="7040880"/>
            <a:ext cx="9326880" cy="831216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046890" y="898737"/>
            <a:ext cx="9326880" cy="6035040"/>
          </a:xfrm>
        </p:spPr>
        <p:txBody>
          <a:bodyPr/>
          <a:lstStyle>
            <a:lvl1pPr marL="0" indent="0">
              <a:buNone/>
              <a:defRPr sz="5100"/>
            </a:lvl1pPr>
            <a:lvl2pPr marL="731520" indent="0">
              <a:buNone/>
              <a:defRPr sz="4500"/>
            </a:lvl2pPr>
            <a:lvl3pPr marL="1463040" indent="0">
              <a:buNone/>
              <a:defRPr sz="380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6890" y="7872096"/>
            <a:ext cx="9326880" cy="1180464"/>
          </a:xfrm>
        </p:spPr>
        <p:txBody>
          <a:bodyPr/>
          <a:lstStyle>
            <a:lvl1pPr marL="0" indent="0">
              <a:buNone/>
              <a:defRPr sz="2200"/>
            </a:lvl1pPr>
            <a:lvl2pPr marL="731520" indent="0">
              <a:buNone/>
              <a:defRPr sz="1900"/>
            </a:lvl2pPr>
            <a:lvl3pPr marL="1463040" indent="0">
              <a:buNone/>
              <a:defRPr sz="1600"/>
            </a:lvl3pPr>
            <a:lvl4pPr marL="2194560" indent="0">
              <a:buNone/>
              <a:defRPr sz="1400"/>
            </a:lvl4pPr>
            <a:lvl5pPr marL="2926080" indent="0">
              <a:buNone/>
              <a:defRPr sz="1400"/>
            </a:lvl5pPr>
            <a:lvl6pPr marL="3657600" indent="0">
              <a:buNone/>
              <a:defRPr sz="1400"/>
            </a:lvl6pPr>
            <a:lvl7pPr marL="4389120" indent="0">
              <a:buNone/>
              <a:defRPr sz="1400"/>
            </a:lvl7pPr>
            <a:lvl8pPr marL="5120640" indent="0">
              <a:buNone/>
              <a:defRPr sz="1400"/>
            </a:lvl8pPr>
            <a:lvl9pPr marL="585216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33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7240" y="402802"/>
            <a:ext cx="13990320" cy="1676400"/>
          </a:xfrm>
          <a:prstGeom prst="rect">
            <a:avLst/>
          </a:prstGeom>
        </p:spPr>
        <p:txBody>
          <a:bodyPr vert="horz" lIns="146304" tIns="73152" rIns="146304" bIns="73152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7240" y="2346961"/>
            <a:ext cx="13990320" cy="6638079"/>
          </a:xfrm>
          <a:prstGeom prst="rect">
            <a:avLst/>
          </a:prstGeom>
        </p:spPr>
        <p:txBody>
          <a:bodyPr vert="horz" lIns="146304" tIns="73152" rIns="146304" bIns="73152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72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570E-694B-493F-911C-A6838F9D8FB2}" type="datetimeFigureOut">
              <a:rPr lang="en-US" smtClean="0"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11140" y="9322647"/>
            <a:ext cx="49225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40440" y="9322647"/>
            <a:ext cx="3627120" cy="535517"/>
          </a:xfrm>
          <a:prstGeom prst="rect">
            <a:avLst/>
          </a:prstGeom>
        </p:spPr>
        <p:txBody>
          <a:bodyPr vert="horz" lIns="146304" tIns="73152" rIns="146304" bIns="73152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A3D7E-9E4A-43B4-893C-6707D36F1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393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63040" rtl="0" eaLnBrk="1" latinLnBrk="0" hangingPunct="1">
        <a:spcBef>
          <a:spcPct val="0"/>
        </a:spcBef>
        <a:buNone/>
        <a:defRPr sz="7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8640" indent="-54864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indent="-45720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6961548"/>
              </p:ext>
            </p:extLst>
          </p:nvPr>
        </p:nvGraphicFramePr>
        <p:xfrm>
          <a:off x="228600" y="990600"/>
          <a:ext cx="14706600" cy="8729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066800" y="533400"/>
            <a:ext cx="14249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dditional file 4: Figure S3 </a:t>
            </a:r>
            <a:r>
              <a:rPr lang="en-US" sz="1600" dirty="0"/>
              <a:t>: Mortality rates of </a:t>
            </a:r>
            <a:r>
              <a:rPr lang="en-US" sz="1600" i="1" dirty="0" err="1"/>
              <a:t>An.gambiae</a:t>
            </a:r>
            <a:r>
              <a:rPr lang="en-US" sz="1600" dirty="0"/>
              <a:t> </a:t>
            </a:r>
            <a:r>
              <a:rPr lang="en-US" sz="1600" dirty="0" smtClean="0"/>
              <a:t>(</a:t>
            </a:r>
            <a:r>
              <a:rPr lang="en-US" sz="1600" dirty="0" err="1" smtClean="0"/>
              <a:t>s.l.</a:t>
            </a:r>
            <a:r>
              <a:rPr lang="en-US" sz="1600" dirty="0" smtClean="0"/>
              <a:t>) </a:t>
            </a:r>
            <a:r>
              <a:rPr lang="en-US" sz="1600" dirty="0"/>
              <a:t>field populations exposed to alpha-</a:t>
            </a:r>
            <a:r>
              <a:rPr lang="en-US" sz="1600" dirty="0" err="1"/>
              <a:t>cypermethrin</a:t>
            </a:r>
            <a:r>
              <a:rPr lang="en-US" sz="1600" dirty="0"/>
              <a:t>, permethrin, </a:t>
            </a:r>
            <a:r>
              <a:rPr lang="en-US" sz="1600" dirty="0" err="1"/>
              <a:t>deltamethrin</a:t>
            </a:r>
            <a:r>
              <a:rPr lang="en-US" sz="1600" dirty="0"/>
              <a:t> and lambda-</a:t>
            </a:r>
            <a:r>
              <a:rPr lang="en-US" sz="1600" dirty="0" err="1"/>
              <a:t>cyhalothrin</a:t>
            </a:r>
            <a:r>
              <a:rPr lang="en-US" sz="1600" dirty="0"/>
              <a:t>  diagnostic dosages </a:t>
            </a:r>
            <a:r>
              <a:rPr lang="en-US" sz="1600"/>
              <a:t>between </a:t>
            </a:r>
            <a:r>
              <a:rPr lang="en-US" sz="1600" smtClean="0"/>
              <a:t>2015 </a:t>
            </a:r>
            <a:r>
              <a:rPr lang="en-US" sz="1600"/>
              <a:t>and </a:t>
            </a:r>
            <a:r>
              <a:rPr lang="en-US" sz="1600" smtClean="0"/>
              <a:t>2016 </a:t>
            </a:r>
            <a:r>
              <a:rPr lang="en-US" sz="1600" dirty="0"/>
              <a:t>in </a:t>
            </a:r>
            <a:r>
              <a:rPr lang="en-US" sz="1600" dirty="0" smtClean="0"/>
              <a:t>eleven </a:t>
            </a:r>
            <a:r>
              <a:rPr lang="en-US" sz="1600" dirty="0"/>
              <a:t>sentinel sites in </a:t>
            </a:r>
            <a:r>
              <a:rPr lang="en-US" sz="1600" dirty="0" smtClean="0"/>
              <a:t>Madagascar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26129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bt Associates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Sabol</dc:creator>
  <cp:lastModifiedBy>Dereje Dengela</cp:lastModifiedBy>
  <cp:revision>10</cp:revision>
  <dcterms:created xsi:type="dcterms:W3CDTF">2017-06-02T01:57:24Z</dcterms:created>
  <dcterms:modified xsi:type="dcterms:W3CDTF">2017-08-15T11:35:24Z</dcterms:modified>
</cp:coreProperties>
</file>